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64" r:id="rId4"/>
    <p:sldId id="262" r:id="rId5"/>
    <p:sldId id="263" r:id="rId6"/>
    <p:sldId id="265" r:id="rId7"/>
    <p:sldId id="261" r:id="rId8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7"/>
    <p:restoredTop sz="94660"/>
  </p:normalViewPr>
  <p:slideViewPr>
    <p:cSldViewPr snapToGrid="0">
      <p:cViewPr varScale="1">
        <p:scale>
          <a:sx n="76" d="100"/>
          <a:sy n="76" d="100"/>
        </p:scale>
        <p:origin x="317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45C1CA-88CD-43C1-932F-312C47C934F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F276392-AF87-4B0A-B6C5-34695EE2191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15D5CF-0DFA-457B-A0F3-BB37469570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9DEE5-C060-4659-91ED-46D3F271B9D9}" type="datetimeFigureOut">
              <a:rPr lang="en-US" smtClean="0"/>
              <a:t>7/1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8E4525-FEA1-406C-8061-AE5426059D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EF701D-D094-4EB2-A988-AAD4AA1383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C978B-FBE6-4374-8931-29F0D0ABC5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96182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54C117-E9A7-41FE-96A4-FA96396CA9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2022778-7476-43FD-A49C-7677CE2CC8B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9E6309-BCAF-4F73-9F68-6A38A07369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9DEE5-C060-4659-91ED-46D3F271B9D9}" type="datetimeFigureOut">
              <a:rPr lang="en-US" smtClean="0"/>
              <a:t>7/1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4EBA08-C0C9-4937-919D-6ADF21EE42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C9A0B6-CC2B-4E05-A827-A7BD8F2756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C978B-FBE6-4374-8931-29F0D0ABC5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06893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593559D-2E61-4CF3-9693-CEC5051DC14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E11611D-6EE1-4422-A3E0-23413641D56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924088-9B63-4671-A4D6-2FCD09B71B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9DEE5-C060-4659-91ED-46D3F271B9D9}" type="datetimeFigureOut">
              <a:rPr lang="en-US" smtClean="0"/>
              <a:t>7/1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AC9A84-E3E8-4CC6-B04C-B8CC6D6C2D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CCE2E1-161A-4E9D-BCC6-25F91C0F25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C978B-FBE6-4374-8931-29F0D0ABC5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06296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8BBAA7-DFF1-4A94-AF4F-E393DAAD1A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B802B3E-87DA-4BAC-8CCF-AE361A6FA5C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6EA937-DD01-49C8-9171-BECB81C743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9DEE5-C060-4659-91ED-46D3F271B9D9}" type="datetimeFigureOut">
              <a:rPr lang="en-US" smtClean="0"/>
              <a:t>7/1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FD4A3A-51C2-452F-9DCB-1C71E5AC97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9872B8-0885-472C-93ED-8EBE831233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C978B-FBE6-4374-8931-29F0D0ABC5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35079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5C0542-A0CF-4387-BB3D-B466A1714E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526B697-2549-46CF-8F59-545AACDF89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04B54D-40CD-40C6-93E8-554677C3EF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9DEE5-C060-4659-91ED-46D3F271B9D9}" type="datetimeFigureOut">
              <a:rPr lang="en-US" smtClean="0"/>
              <a:t>7/1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80EEFF-C0F6-4D41-9480-4A2E023A2D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4D84D1-518C-4270-840D-A29E20C046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C978B-FBE6-4374-8931-29F0D0ABC5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23160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04D5AF-BBD3-4AAB-B748-B235CDAEF8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C26BC87-AB58-4655-BFDB-EF3923F2DCD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EF41107-1F82-4F47-9CCC-599AC7C7B67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34B134C-9D7A-475D-9FA1-54936DB1E4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9DEE5-C060-4659-91ED-46D3F271B9D9}" type="datetimeFigureOut">
              <a:rPr lang="en-US" smtClean="0"/>
              <a:t>7/1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890DA4B-9369-4E2D-8E6C-5185520CE1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22A4D4-A1D6-4606-84C1-EB3487DF89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C978B-FBE6-4374-8931-29F0D0ABC5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7893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5ADBDD-DA88-4380-94C0-BA4B50D9D2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96D34C5-C5D4-4D2B-935A-84471A29C3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C34BD2-6B76-45D8-8292-E99A4072C0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87B3233-254A-404A-B201-F9E0976D73D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4242D9F-9EA9-4ED2-BB8F-0A61A3B0CF6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FA23ACA-503A-4611-9CAC-A24EFEF020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9DEE5-C060-4659-91ED-46D3F271B9D9}" type="datetimeFigureOut">
              <a:rPr lang="en-US" smtClean="0"/>
              <a:t>7/14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A168DE2-A832-49B3-9EAA-6CF1E2E7F9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DDA99A0-068A-4A19-B14A-7E92E3268F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C978B-FBE6-4374-8931-29F0D0ABC5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26312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321554-0B8C-4CD4-A20F-08208BD7BF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5E580B2-6644-45C6-9F99-A725B77AA8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9DEE5-C060-4659-91ED-46D3F271B9D9}" type="datetimeFigureOut">
              <a:rPr lang="en-US" smtClean="0"/>
              <a:t>7/14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1033C10-8AAF-4956-9FFF-24AF698A35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DACB21C-8621-4892-9063-9503B66308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C978B-FBE6-4374-8931-29F0D0ABC5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28162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EF9DEC8-F056-4FBA-8B7B-2D64A93DA5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9DEE5-C060-4659-91ED-46D3F271B9D9}" type="datetimeFigureOut">
              <a:rPr lang="en-US" smtClean="0"/>
              <a:t>7/14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8E2C5A9-CEAD-4F8C-A9A5-8F42AB3482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904910C-1286-4FAD-8DCA-0D6B1A7072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C978B-FBE6-4374-8931-29F0D0ABC5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5372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AD2435-6512-4D89-8367-5F61DB77C1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1A2DA6-57A6-423E-8C66-6A648B4640B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DD61DE9-EFE1-4170-BD95-7BD4234ECF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314CE7D-BC02-46BA-A0F2-C85954A027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9DEE5-C060-4659-91ED-46D3F271B9D9}" type="datetimeFigureOut">
              <a:rPr lang="en-US" smtClean="0"/>
              <a:t>7/1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2068232-88D0-4975-A4F6-5A8181BE75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BB8C629-13AD-4DF4-BA0D-29AE7746A9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C978B-FBE6-4374-8931-29F0D0ABC5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74258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D43BE5-9E5E-4533-A26A-23EB406D72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F915205-F2B7-430A-A211-00D29187978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F1518C4-264F-4578-9D79-8448580074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B5C51CF-3441-4D65-A2FB-499B76E43D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9DEE5-C060-4659-91ED-46D3F271B9D9}" type="datetimeFigureOut">
              <a:rPr lang="en-US" smtClean="0"/>
              <a:t>7/1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73803AF-2A46-43AD-9F0F-5248FF5066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DFA2F1-41A5-42B7-8475-F16E556248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C978B-FBE6-4374-8931-29F0D0ABC5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87561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02230C0-BBB7-4EE4-B401-A9D8C2F2B3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7641E2-14BC-4544-96CA-C6E2D531D0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4DAD38-DF11-4761-B0F5-817534BA2C8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69DEE5-C060-4659-91ED-46D3F271B9D9}" type="datetimeFigureOut">
              <a:rPr lang="en-US" smtClean="0"/>
              <a:t>7/1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73066C-BACF-44A1-9035-5AB86FF7DBE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9F5B54-9C12-4482-BB70-506D1226C99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CC978B-FBE6-4374-8931-29F0D0ABC5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29229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874388F4-4E74-4886-A0E4-0AF6077191D1}"/>
              </a:ext>
            </a:extLst>
          </p:cNvPr>
          <p:cNvGrpSpPr/>
          <p:nvPr/>
        </p:nvGrpSpPr>
        <p:grpSpPr>
          <a:xfrm>
            <a:off x="104910" y="461347"/>
            <a:ext cx="6412112" cy="2415203"/>
            <a:chOff x="219210" y="2912447"/>
            <a:chExt cx="6412112" cy="2415203"/>
          </a:xfrm>
        </p:grpSpPr>
        <p:pic>
          <p:nvPicPr>
            <p:cNvPr id="5" name="Picture 4" descr="A picture containing chart&#10;&#10;Description automatically generated">
              <a:extLst>
                <a:ext uri="{FF2B5EF4-FFF2-40B4-BE49-F238E27FC236}">
                  <a16:creationId xmlns:a16="http://schemas.microsoft.com/office/drawing/2014/main" id="{7DE24361-2B18-4A44-9EBA-91D8B99750F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89" t="5002" r="10680" b="28600"/>
            <a:stretch/>
          </p:blipFill>
          <p:spPr>
            <a:xfrm>
              <a:off x="219210" y="2912447"/>
              <a:ext cx="6412112" cy="2415203"/>
            </a:xfrm>
            <a:prstGeom prst="rect">
              <a:avLst/>
            </a:prstGeom>
          </p:spPr>
        </p:pic>
        <p:cxnSp>
          <p:nvCxnSpPr>
            <p:cNvPr id="6" name="Straight Arrow Connector 5">
              <a:extLst>
                <a:ext uri="{FF2B5EF4-FFF2-40B4-BE49-F238E27FC236}">
                  <a16:creationId xmlns:a16="http://schemas.microsoft.com/office/drawing/2014/main" id="{8C2486E9-68A9-43BC-B3DA-945046B2806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64166" y="4978202"/>
              <a:ext cx="0" cy="166590"/>
            </a:xfrm>
            <a:prstGeom prst="straightConnector1">
              <a:avLst/>
            </a:prstGeom>
            <a:ln w="38100">
              <a:solidFill>
                <a:srgbClr val="C00000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2664A197-AC01-44E6-9663-450168CCF001}"/>
              </a:ext>
            </a:extLst>
          </p:cNvPr>
          <p:cNvSpPr txBox="1"/>
          <p:nvPr/>
        </p:nvSpPr>
        <p:spPr>
          <a:xfrm>
            <a:off x="281971" y="3268217"/>
            <a:ext cx="605799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just"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b="1" dirty="0"/>
              <a:t>Supplementary Figure 1 </a:t>
            </a:r>
            <a:r>
              <a:rPr lang="en-US" dirty="0"/>
              <a:t>Hierarchical clustering of samples used in this study. The dendrogram is built based on gene expressions quantified with Transcripts Per Million (TPM ≥ 0.1). The distance between individuals is indicated by 1-r, where r is the Pearson correlation coefficient.</a:t>
            </a:r>
          </a:p>
        </p:txBody>
      </p:sp>
    </p:spTree>
    <p:extLst>
      <p:ext uri="{BB962C8B-B14F-4D97-AF65-F5344CB8AC3E}">
        <p14:creationId xmlns:p14="http://schemas.microsoft.com/office/powerpoint/2010/main" val="22399556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86C4DB10-7518-4146-A950-FD8BC130C88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2422" y="657740"/>
            <a:ext cx="2864477" cy="2864477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27A8EC35-9DA3-4E75-9B42-174585945DD1}"/>
              </a:ext>
            </a:extLst>
          </p:cNvPr>
          <p:cNvSpPr txBox="1"/>
          <p:nvPr/>
        </p:nvSpPr>
        <p:spPr>
          <a:xfrm>
            <a:off x="484706" y="3687317"/>
            <a:ext cx="605799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just"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b="1" dirty="0"/>
              <a:t>Supplementary Figure 2 </a:t>
            </a:r>
            <a:r>
              <a:rPr lang="en-US" dirty="0" err="1"/>
              <a:t>Dotplot</a:t>
            </a:r>
            <a:r>
              <a:rPr lang="en-US" dirty="0"/>
              <a:t> depicting the number of sequencing reads (x-axis) and the number of expressed genes (y-axis). A given gene was considered as expressed when Transcripts Per Million (TPM) &gt;= 0.1. The red text indicates the outlier sample in principal component analysis (PCA) plot (Figures 1b) and hierarchical clustering (Figure S1).</a:t>
            </a:r>
          </a:p>
        </p:txBody>
      </p:sp>
    </p:spTree>
    <p:extLst>
      <p:ext uri="{BB962C8B-B14F-4D97-AF65-F5344CB8AC3E}">
        <p14:creationId xmlns:p14="http://schemas.microsoft.com/office/powerpoint/2010/main" val="24268844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A3C554A1-10C0-3147-AB1E-A9C54EE7A9F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1354" y="400817"/>
            <a:ext cx="5003800" cy="38100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D189782F-5D26-254D-ABC5-76FD4A59D827}"/>
              </a:ext>
            </a:extLst>
          </p:cNvPr>
          <p:cNvSpPr txBox="1"/>
          <p:nvPr/>
        </p:nvSpPr>
        <p:spPr>
          <a:xfrm>
            <a:off x="400005" y="4583668"/>
            <a:ext cx="605799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just"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b="1" dirty="0"/>
              <a:t>Supplementary Figure 3 </a:t>
            </a:r>
            <a:r>
              <a:rPr lang="en-US" dirty="0" err="1"/>
              <a:t>GffCompare</a:t>
            </a:r>
            <a:r>
              <a:rPr lang="en-US" dirty="0"/>
              <a:t> types when comparing our predicted transcripts to NCBI annotation (V105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6A9A442-9709-7D41-BA41-E9298F49BF2D}"/>
              </a:ext>
            </a:extLst>
          </p:cNvPr>
          <p:cNvSpPr txBox="1"/>
          <p:nvPr/>
        </p:nvSpPr>
        <p:spPr>
          <a:xfrm>
            <a:off x="4949591" y="1925739"/>
            <a:ext cx="13692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ovel isoform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91D6D21-0D8E-2B41-B0F7-56B7DFB647F3}"/>
              </a:ext>
            </a:extLst>
          </p:cNvPr>
          <p:cNvSpPr txBox="1"/>
          <p:nvPr/>
        </p:nvSpPr>
        <p:spPr>
          <a:xfrm>
            <a:off x="4991129" y="3140047"/>
            <a:ext cx="9621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ovel loci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4F2A2AE-D6A9-A747-93CA-38931FB7E631}"/>
              </a:ext>
            </a:extLst>
          </p:cNvPr>
          <p:cNvSpPr txBox="1"/>
          <p:nvPr/>
        </p:nvSpPr>
        <p:spPr>
          <a:xfrm>
            <a:off x="4949591" y="1077803"/>
            <a:ext cx="11705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Exact match</a:t>
            </a: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BE94FF31-8B1E-FB46-AE79-F089EF7EFAE1}"/>
              </a:ext>
            </a:extLst>
          </p:cNvPr>
          <p:cNvCxnSpPr>
            <a:cxnSpLocks/>
            <a:endCxn id="11" idx="1"/>
          </p:cNvCxnSpPr>
          <p:nvPr/>
        </p:nvCxnSpPr>
        <p:spPr>
          <a:xfrm>
            <a:off x="4759948" y="1231692"/>
            <a:ext cx="189643" cy="0"/>
          </a:xfrm>
          <a:prstGeom prst="straightConnector1">
            <a:avLst/>
          </a:prstGeom>
          <a:ln w="1270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Right Brace 12">
            <a:extLst>
              <a:ext uri="{FF2B5EF4-FFF2-40B4-BE49-F238E27FC236}">
                <a16:creationId xmlns:a16="http://schemas.microsoft.com/office/drawing/2014/main" id="{92DEA886-3F00-D147-90B6-5726D1CBABD3}"/>
              </a:ext>
            </a:extLst>
          </p:cNvPr>
          <p:cNvSpPr/>
          <p:nvPr/>
        </p:nvSpPr>
        <p:spPr>
          <a:xfrm>
            <a:off x="4764607" y="1457232"/>
            <a:ext cx="146474" cy="1244793"/>
          </a:xfrm>
          <a:prstGeom prst="rightBrace">
            <a:avLst>
              <a:gd name="adj1" fmla="val 47988"/>
              <a:gd name="adj2" fmla="val 50567"/>
            </a:avLst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ight Brace 13">
            <a:extLst>
              <a:ext uri="{FF2B5EF4-FFF2-40B4-BE49-F238E27FC236}">
                <a16:creationId xmlns:a16="http://schemas.microsoft.com/office/drawing/2014/main" id="{A5BE1EFD-D4E3-414F-911E-881D50DEB0DE}"/>
              </a:ext>
            </a:extLst>
          </p:cNvPr>
          <p:cNvSpPr/>
          <p:nvPr/>
        </p:nvSpPr>
        <p:spPr>
          <a:xfrm>
            <a:off x="4759948" y="2892348"/>
            <a:ext cx="151133" cy="803177"/>
          </a:xfrm>
          <a:prstGeom prst="rightBrace">
            <a:avLst>
              <a:gd name="adj1" fmla="val 47988"/>
              <a:gd name="adj2" fmla="val 50567"/>
            </a:avLst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89222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705AE431-22B2-9C46-9142-23B32020178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9257" y="4347173"/>
            <a:ext cx="4126511" cy="3594744"/>
          </a:xfrm>
          <a:prstGeom prst="rect">
            <a:avLst/>
          </a:prstGeom>
          <a:ln>
            <a:noFill/>
          </a:ln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7D88BEB3-E8F2-0E4B-8B87-0E034D607BA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5979" y="574859"/>
            <a:ext cx="4118030" cy="3612492"/>
          </a:xfrm>
          <a:prstGeom prst="rect">
            <a:avLst/>
          </a:prstGeom>
          <a:ln>
            <a:noFill/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0463396-FFFE-ED4D-8898-43A5B71859BA}"/>
              </a:ext>
            </a:extLst>
          </p:cNvPr>
          <p:cNvSpPr txBox="1"/>
          <p:nvPr/>
        </p:nvSpPr>
        <p:spPr>
          <a:xfrm>
            <a:off x="4764001" y="1555671"/>
            <a:ext cx="13692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ovel isoform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4671796-BA12-4C48-9911-A439A12AE642}"/>
              </a:ext>
            </a:extLst>
          </p:cNvPr>
          <p:cNvSpPr txBox="1"/>
          <p:nvPr/>
        </p:nvSpPr>
        <p:spPr>
          <a:xfrm>
            <a:off x="4761134" y="2664109"/>
            <a:ext cx="9621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ovel loci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E642307-B386-6B4E-A452-F55B2060474E}"/>
              </a:ext>
            </a:extLst>
          </p:cNvPr>
          <p:cNvSpPr txBox="1"/>
          <p:nvPr/>
        </p:nvSpPr>
        <p:spPr>
          <a:xfrm>
            <a:off x="4761134" y="3423739"/>
            <a:ext cx="15584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otential artifact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CCA68F8-1AD3-ED4B-A4C1-34BA4091754F}"/>
              </a:ext>
            </a:extLst>
          </p:cNvPr>
          <p:cNvSpPr txBox="1"/>
          <p:nvPr/>
        </p:nvSpPr>
        <p:spPr>
          <a:xfrm>
            <a:off x="4764001" y="754542"/>
            <a:ext cx="11705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Exact match</a:t>
            </a: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33F01263-7DEA-4F47-95D8-DE50B91B3AE6}"/>
              </a:ext>
            </a:extLst>
          </p:cNvPr>
          <p:cNvCxnSpPr>
            <a:cxnSpLocks/>
            <a:endCxn id="5" idx="1"/>
          </p:cNvCxnSpPr>
          <p:nvPr/>
        </p:nvCxnSpPr>
        <p:spPr>
          <a:xfrm>
            <a:off x="4507535" y="906459"/>
            <a:ext cx="256466" cy="1972"/>
          </a:xfrm>
          <a:prstGeom prst="straightConnector1">
            <a:avLst/>
          </a:prstGeom>
          <a:ln w="1270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Right Brace 12">
            <a:extLst>
              <a:ext uri="{FF2B5EF4-FFF2-40B4-BE49-F238E27FC236}">
                <a16:creationId xmlns:a16="http://schemas.microsoft.com/office/drawing/2014/main" id="{4849B88F-083F-184A-A350-D0BCE4E32D94}"/>
              </a:ext>
            </a:extLst>
          </p:cNvPr>
          <p:cNvSpPr/>
          <p:nvPr/>
        </p:nvSpPr>
        <p:spPr>
          <a:xfrm>
            <a:off x="4507535" y="1145734"/>
            <a:ext cx="146474" cy="1127653"/>
          </a:xfrm>
          <a:prstGeom prst="rightBrace">
            <a:avLst>
              <a:gd name="adj1" fmla="val 47988"/>
              <a:gd name="adj2" fmla="val 50567"/>
            </a:avLst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ight Brace 14">
            <a:extLst>
              <a:ext uri="{FF2B5EF4-FFF2-40B4-BE49-F238E27FC236}">
                <a16:creationId xmlns:a16="http://schemas.microsoft.com/office/drawing/2014/main" id="{BA719821-D6D0-6148-A799-3E3EF6803DEA}"/>
              </a:ext>
            </a:extLst>
          </p:cNvPr>
          <p:cNvSpPr/>
          <p:nvPr/>
        </p:nvSpPr>
        <p:spPr>
          <a:xfrm>
            <a:off x="4502876" y="2467668"/>
            <a:ext cx="151133" cy="700661"/>
          </a:xfrm>
          <a:prstGeom prst="rightBrace">
            <a:avLst>
              <a:gd name="adj1" fmla="val 47988"/>
              <a:gd name="adj2" fmla="val 50567"/>
            </a:avLst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ight Brace 15">
            <a:extLst>
              <a:ext uri="{FF2B5EF4-FFF2-40B4-BE49-F238E27FC236}">
                <a16:creationId xmlns:a16="http://schemas.microsoft.com/office/drawing/2014/main" id="{5E598A84-8DB9-1842-A5C1-78350796A147}"/>
              </a:ext>
            </a:extLst>
          </p:cNvPr>
          <p:cNvSpPr/>
          <p:nvPr/>
        </p:nvSpPr>
        <p:spPr>
          <a:xfrm>
            <a:off x="4509564" y="3361200"/>
            <a:ext cx="144445" cy="432856"/>
          </a:xfrm>
          <a:prstGeom prst="rightBrace">
            <a:avLst>
              <a:gd name="adj1" fmla="val 47988"/>
              <a:gd name="adj2" fmla="val 50567"/>
            </a:avLst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1AE97F1-7D69-8B45-9A2C-4F5E305F5447}"/>
              </a:ext>
            </a:extLst>
          </p:cNvPr>
          <p:cNvSpPr txBox="1"/>
          <p:nvPr/>
        </p:nvSpPr>
        <p:spPr>
          <a:xfrm>
            <a:off x="400005" y="8088719"/>
            <a:ext cx="605799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just"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b="1" dirty="0"/>
              <a:t>Supplementary Figure 4 </a:t>
            </a:r>
            <a:r>
              <a:rPr lang="en-US" dirty="0" err="1"/>
              <a:t>GffCompare</a:t>
            </a:r>
            <a:r>
              <a:rPr lang="en-US" dirty="0"/>
              <a:t> types when comparing protein-coding (a) and lncRNA loci (b) predicted in this study with those predicted in </a:t>
            </a:r>
            <a:r>
              <a:rPr lang="en-US" dirty="0" err="1"/>
              <a:t>Jehl</a:t>
            </a:r>
            <a:r>
              <a:rPr lang="en-US" dirty="0"/>
              <a:t> et al., 2020.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252FDF1-8A55-0E4C-8F73-71485016976D}"/>
              </a:ext>
            </a:extLst>
          </p:cNvPr>
          <p:cNvSpPr txBox="1"/>
          <p:nvPr/>
        </p:nvSpPr>
        <p:spPr>
          <a:xfrm>
            <a:off x="4823649" y="5409578"/>
            <a:ext cx="13692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ovel isoforms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7A3A438-A250-9F45-900B-82787C1D2A6C}"/>
              </a:ext>
            </a:extLst>
          </p:cNvPr>
          <p:cNvSpPr txBox="1"/>
          <p:nvPr/>
        </p:nvSpPr>
        <p:spPr>
          <a:xfrm>
            <a:off x="4820782" y="6391981"/>
            <a:ext cx="9621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ovel loci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48414A3-0BF5-184E-ABA5-DD5CE5DC5E58}"/>
              </a:ext>
            </a:extLst>
          </p:cNvPr>
          <p:cNvSpPr txBox="1"/>
          <p:nvPr/>
        </p:nvSpPr>
        <p:spPr>
          <a:xfrm>
            <a:off x="4820782" y="7111508"/>
            <a:ext cx="15584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otential artifacts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C7049FD-A4BA-7447-97D2-E57C373D1ECC}"/>
              </a:ext>
            </a:extLst>
          </p:cNvPr>
          <p:cNvSpPr txBox="1"/>
          <p:nvPr/>
        </p:nvSpPr>
        <p:spPr>
          <a:xfrm>
            <a:off x="4823649" y="4670903"/>
            <a:ext cx="11705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Exact match</a:t>
            </a: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08294A87-0396-2D49-80AB-8F6E32961779}"/>
              </a:ext>
            </a:extLst>
          </p:cNvPr>
          <p:cNvCxnSpPr>
            <a:cxnSpLocks/>
            <a:endCxn id="21" idx="1"/>
          </p:cNvCxnSpPr>
          <p:nvPr/>
        </p:nvCxnSpPr>
        <p:spPr>
          <a:xfrm>
            <a:off x="4567183" y="4822820"/>
            <a:ext cx="256466" cy="1972"/>
          </a:xfrm>
          <a:prstGeom prst="straightConnector1">
            <a:avLst/>
          </a:prstGeom>
          <a:ln w="1270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Right Brace 22">
            <a:extLst>
              <a:ext uri="{FF2B5EF4-FFF2-40B4-BE49-F238E27FC236}">
                <a16:creationId xmlns:a16="http://schemas.microsoft.com/office/drawing/2014/main" id="{0C4887F6-4C4A-764F-B4B7-B5A03C1CD667}"/>
              </a:ext>
            </a:extLst>
          </p:cNvPr>
          <p:cNvSpPr/>
          <p:nvPr/>
        </p:nvSpPr>
        <p:spPr>
          <a:xfrm>
            <a:off x="4567183" y="5031642"/>
            <a:ext cx="146474" cy="1043860"/>
          </a:xfrm>
          <a:prstGeom prst="rightBrace">
            <a:avLst>
              <a:gd name="adj1" fmla="val 47988"/>
              <a:gd name="adj2" fmla="val 50567"/>
            </a:avLst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ight Brace 23">
            <a:extLst>
              <a:ext uri="{FF2B5EF4-FFF2-40B4-BE49-F238E27FC236}">
                <a16:creationId xmlns:a16="http://schemas.microsoft.com/office/drawing/2014/main" id="{5370506D-D6B3-2042-93E7-4B83E0860C62}"/>
              </a:ext>
            </a:extLst>
          </p:cNvPr>
          <p:cNvSpPr/>
          <p:nvPr/>
        </p:nvSpPr>
        <p:spPr>
          <a:xfrm>
            <a:off x="4562524" y="6231224"/>
            <a:ext cx="151133" cy="645313"/>
          </a:xfrm>
          <a:prstGeom prst="rightBrace">
            <a:avLst>
              <a:gd name="adj1" fmla="val 47988"/>
              <a:gd name="adj2" fmla="val 50567"/>
            </a:avLst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ight Brace 24">
            <a:extLst>
              <a:ext uri="{FF2B5EF4-FFF2-40B4-BE49-F238E27FC236}">
                <a16:creationId xmlns:a16="http://schemas.microsoft.com/office/drawing/2014/main" id="{283BB18F-299F-6342-8152-8D3C08AB008E}"/>
              </a:ext>
            </a:extLst>
          </p:cNvPr>
          <p:cNvSpPr/>
          <p:nvPr/>
        </p:nvSpPr>
        <p:spPr>
          <a:xfrm>
            <a:off x="4569212" y="7059577"/>
            <a:ext cx="144445" cy="432856"/>
          </a:xfrm>
          <a:prstGeom prst="rightBrace">
            <a:avLst>
              <a:gd name="adj1" fmla="val 47988"/>
              <a:gd name="adj2" fmla="val 50567"/>
            </a:avLst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92463F4-2488-0E48-BC10-EDCB078E9F7C}"/>
              </a:ext>
            </a:extLst>
          </p:cNvPr>
          <p:cNvSpPr txBox="1"/>
          <p:nvPr/>
        </p:nvSpPr>
        <p:spPr>
          <a:xfrm>
            <a:off x="699247" y="640687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6D38C77-84BC-F64D-BC99-61CA6F19D926}"/>
              </a:ext>
            </a:extLst>
          </p:cNvPr>
          <p:cNvSpPr txBox="1"/>
          <p:nvPr/>
        </p:nvSpPr>
        <p:spPr>
          <a:xfrm>
            <a:off x="699247" y="4347173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72125753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5E0DD86-D380-3647-82E0-6562B118788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2741"/>
          <a:stretch/>
        </p:blipFill>
        <p:spPr>
          <a:xfrm>
            <a:off x="175640" y="586749"/>
            <a:ext cx="5042230" cy="42545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89080903-159E-3246-AF77-88F7299C072E}"/>
              </a:ext>
            </a:extLst>
          </p:cNvPr>
          <p:cNvSpPr txBox="1"/>
          <p:nvPr/>
        </p:nvSpPr>
        <p:spPr>
          <a:xfrm>
            <a:off x="353770" y="4953000"/>
            <a:ext cx="605799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just"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b="1" dirty="0"/>
              <a:t>Supplementary Figure 5 </a:t>
            </a:r>
            <a:r>
              <a:rPr lang="en-US" dirty="0" err="1"/>
              <a:t>GffCompare</a:t>
            </a:r>
            <a:r>
              <a:rPr lang="en-US" dirty="0"/>
              <a:t> types when comparing novel transcripts reported by Thomas et al. (2014) to our annotation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9780990-D764-0D4E-86DF-96EAA5F4F037}"/>
              </a:ext>
            </a:extLst>
          </p:cNvPr>
          <p:cNvSpPr txBox="1"/>
          <p:nvPr/>
        </p:nvSpPr>
        <p:spPr>
          <a:xfrm>
            <a:off x="4627954" y="1902872"/>
            <a:ext cx="13692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ovel isoform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2093D3E-B65D-3946-BF7D-F44DAA4AB500}"/>
              </a:ext>
            </a:extLst>
          </p:cNvPr>
          <p:cNvSpPr txBox="1"/>
          <p:nvPr/>
        </p:nvSpPr>
        <p:spPr>
          <a:xfrm>
            <a:off x="4627954" y="3544665"/>
            <a:ext cx="9621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ovel loci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5FA6D09-6D94-F14B-BF16-A9A189ADFEA3}"/>
              </a:ext>
            </a:extLst>
          </p:cNvPr>
          <p:cNvSpPr txBox="1"/>
          <p:nvPr/>
        </p:nvSpPr>
        <p:spPr>
          <a:xfrm>
            <a:off x="4624754" y="4318270"/>
            <a:ext cx="15584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otential artifact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1A53AE3-DE4B-294D-9C7E-F5884B8D1C1E}"/>
              </a:ext>
            </a:extLst>
          </p:cNvPr>
          <p:cNvSpPr txBox="1"/>
          <p:nvPr/>
        </p:nvSpPr>
        <p:spPr>
          <a:xfrm>
            <a:off x="4632613" y="775796"/>
            <a:ext cx="11705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Exact match</a:t>
            </a: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50B789A9-A6DF-6043-86A8-3A516070CAB6}"/>
              </a:ext>
            </a:extLst>
          </p:cNvPr>
          <p:cNvCxnSpPr>
            <a:cxnSpLocks/>
            <a:endCxn id="9" idx="1"/>
          </p:cNvCxnSpPr>
          <p:nvPr/>
        </p:nvCxnSpPr>
        <p:spPr>
          <a:xfrm>
            <a:off x="4376147" y="927713"/>
            <a:ext cx="256466" cy="1972"/>
          </a:xfrm>
          <a:prstGeom prst="straightConnector1">
            <a:avLst/>
          </a:prstGeom>
          <a:ln w="1270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Right Brace 10">
            <a:extLst>
              <a:ext uri="{FF2B5EF4-FFF2-40B4-BE49-F238E27FC236}">
                <a16:creationId xmlns:a16="http://schemas.microsoft.com/office/drawing/2014/main" id="{E1087F5C-EAED-B849-976E-03F6737F81DA}"/>
              </a:ext>
            </a:extLst>
          </p:cNvPr>
          <p:cNvSpPr/>
          <p:nvPr/>
        </p:nvSpPr>
        <p:spPr>
          <a:xfrm>
            <a:off x="4371488" y="1270649"/>
            <a:ext cx="256466" cy="1613082"/>
          </a:xfrm>
          <a:prstGeom prst="rightBrace">
            <a:avLst>
              <a:gd name="adj1" fmla="val 47988"/>
              <a:gd name="adj2" fmla="val 50567"/>
            </a:avLst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ight Brace 11">
            <a:extLst>
              <a:ext uri="{FF2B5EF4-FFF2-40B4-BE49-F238E27FC236}">
                <a16:creationId xmlns:a16="http://schemas.microsoft.com/office/drawing/2014/main" id="{D4ACEC50-E4B9-0F4A-9F21-B20F5C6599D8}"/>
              </a:ext>
            </a:extLst>
          </p:cNvPr>
          <p:cNvSpPr/>
          <p:nvPr/>
        </p:nvSpPr>
        <p:spPr>
          <a:xfrm>
            <a:off x="4371488" y="3228870"/>
            <a:ext cx="256466" cy="939369"/>
          </a:xfrm>
          <a:prstGeom prst="rightBrace">
            <a:avLst>
              <a:gd name="adj1" fmla="val 47988"/>
              <a:gd name="adj2" fmla="val 50567"/>
            </a:avLst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010FCB35-ED9B-964C-ABA0-3C3E8DED8999}"/>
              </a:ext>
            </a:extLst>
          </p:cNvPr>
          <p:cNvCxnSpPr>
            <a:cxnSpLocks/>
          </p:cNvCxnSpPr>
          <p:nvPr/>
        </p:nvCxnSpPr>
        <p:spPr>
          <a:xfrm>
            <a:off x="4334031" y="4485279"/>
            <a:ext cx="256466" cy="1972"/>
          </a:xfrm>
          <a:prstGeom prst="straightConnector1">
            <a:avLst/>
          </a:prstGeom>
          <a:ln w="1270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7894096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CF34396B-2C7A-C94D-BF11-E91F7AA7DA17}"/>
              </a:ext>
            </a:extLst>
          </p:cNvPr>
          <p:cNvSpPr txBox="1"/>
          <p:nvPr/>
        </p:nvSpPr>
        <p:spPr>
          <a:xfrm rot="16200000">
            <a:off x="599117" y="1926028"/>
            <a:ext cx="7296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21D8B7F-5E1D-874A-9D95-95BFF0232FB4}"/>
              </a:ext>
            </a:extLst>
          </p:cNvPr>
          <p:cNvSpPr txBox="1"/>
          <p:nvPr/>
        </p:nvSpPr>
        <p:spPr>
          <a:xfrm>
            <a:off x="400005" y="4088719"/>
            <a:ext cx="605799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just"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b="1" dirty="0"/>
              <a:t>Supplementary Figure 6 </a:t>
            </a:r>
            <a:r>
              <a:rPr lang="en-US" dirty="0"/>
              <a:t>Number of expression loci and transcripts (TPM &gt; 0.1) across tissues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4EF97591-0D72-1C4E-9C7F-AF622409CF3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72643" y="781721"/>
            <a:ext cx="4483331" cy="3137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7833911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27A8EC35-9DA3-4E75-9B42-174585945DD1}"/>
              </a:ext>
            </a:extLst>
          </p:cNvPr>
          <p:cNvSpPr txBox="1"/>
          <p:nvPr/>
        </p:nvSpPr>
        <p:spPr>
          <a:xfrm>
            <a:off x="400005" y="5321833"/>
            <a:ext cx="605799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just"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b="1" dirty="0"/>
              <a:t>Supplementary Figure 7 </a:t>
            </a:r>
            <a:r>
              <a:rPr lang="en-US" dirty="0"/>
              <a:t>Number of loci showing differential alternative splicing between tissues   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9C993247-21DB-874A-A2A4-986805F534C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0501" y="118821"/>
            <a:ext cx="5486400" cy="5029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325854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05</TotalTime>
  <Words>242</Words>
  <Application>Microsoft Office PowerPoint</Application>
  <PresentationFormat>A4 Paper (210x297 mm)</PresentationFormat>
  <Paragraphs>25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ILU GUAN</dc:creator>
  <cp:lastModifiedBy>DAILU GUAN</cp:lastModifiedBy>
  <cp:revision>34</cp:revision>
  <dcterms:created xsi:type="dcterms:W3CDTF">2021-08-09T20:41:57Z</dcterms:created>
  <dcterms:modified xsi:type="dcterms:W3CDTF">2022-07-15T00:47:50Z</dcterms:modified>
</cp:coreProperties>
</file>